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1" d="100"/>
          <a:sy n="71" d="100"/>
        </p:scale>
        <p:origin x="-224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24451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20564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7368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6721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45490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9019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5147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13114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19062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1174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72703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27BD0-8113-E945-893F-4B853580CD0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6655E-5022-9447-8837-E3D2C5755FA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4508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1616291"/>
              </p:ext>
            </p:extLst>
          </p:nvPr>
        </p:nvGraphicFramePr>
        <p:xfrm>
          <a:off x="1454150" y="1476851"/>
          <a:ext cx="6438900" cy="3426460"/>
        </p:xfrm>
        <a:graphic>
          <a:graphicData uri="http://schemas.openxmlformats.org/drawingml/2006/table">
            <a:tbl>
              <a:tblPr/>
              <a:tblGrid>
                <a:gridCol w="3022600"/>
                <a:gridCol w="889000"/>
                <a:gridCol w="838200"/>
                <a:gridCol w="825500"/>
                <a:gridCol w="863600"/>
              </a:tblGrid>
              <a:tr h="165100"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dividual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nfidence Variant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303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264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06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672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number of SNP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353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9883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3219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3439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P in coding region or splice site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62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726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91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84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-synonymous SNP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62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3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63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65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F≤0.5% in 1000Genomes,ESP6500,ExAC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9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89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9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8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hared variants in all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ient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ioinformatics prediction deleteriou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number of INDEL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77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76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43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8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DELs in coding region or splice site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5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cluding non-framshift insert or deletion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5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5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F≤0.5% in 1000Genomes,ESP6500,ExAC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7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hared variants in all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ient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ioinformatics prediction deleteriou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ndidate causative genes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  <a:r>
                        <a:rPr lang="en-US" altLang="zh-CN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6 distinct variants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41554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Macintosh PowerPoint</Application>
  <PresentationFormat>全屏显示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1</cp:revision>
  <dcterms:created xsi:type="dcterms:W3CDTF">2018-06-04T06:24:53Z</dcterms:created>
  <dcterms:modified xsi:type="dcterms:W3CDTF">2018-06-04T06:25:09Z</dcterms:modified>
</cp:coreProperties>
</file>